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5"/>
  </p:notesMasterIdLst>
  <p:sldIdLst>
    <p:sldId id="1088" r:id="rId2"/>
    <p:sldId id="1073" r:id="rId3"/>
    <p:sldId id="1080" r:id="rId4"/>
    <p:sldId id="1084" r:id="rId5"/>
    <p:sldId id="1077" r:id="rId6"/>
    <p:sldId id="1075" r:id="rId7"/>
    <p:sldId id="1085" r:id="rId8"/>
    <p:sldId id="1081" r:id="rId9"/>
    <p:sldId id="1086" r:id="rId10"/>
    <p:sldId id="1087" r:id="rId11"/>
    <p:sldId id="1083" r:id="rId12"/>
    <p:sldId id="1058" r:id="rId13"/>
    <p:sldId id="1078" r:id="rId14"/>
  </p:sldIdLst>
  <p:sldSz cx="18288000" cy="10287000"/>
  <p:notesSz cx="6858000" cy="9144000"/>
  <p:embeddedFontLst>
    <p:embeddedFont>
      <p:font typeface="Assistant" pitchFamily="2" charset="-79"/>
      <p:regular r:id="rId16"/>
      <p:bold r:id="rId17"/>
    </p:embeddedFont>
    <p:embeddedFont>
      <p:font typeface="Assistant Bold" charset="-79"/>
      <p:regular r:id="rId18"/>
      <p:bold r:id="rId19"/>
    </p:embeddedFont>
    <p:embeddedFont>
      <p:font typeface="Assistant ExtraBold" pitchFamily="2" charset="-79"/>
      <p:bold r:id="rId20"/>
    </p:embeddedFont>
    <p:embeddedFont>
      <p:font typeface="Assistant Regular" charset="-79"/>
      <p:regular r:id="rId21"/>
    </p:embeddedFont>
    <p:embeddedFont>
      <p:font typeface="Assistant SemiBold" pitchFamily="2" charset="-79"/>
      <p:bold r:id="rId22"/>
    </p:embeddedFont>
    <p:embeddedFont>
      <p:font typeface="Calibri" panose="020F0502020204030204" pitchFamily="34" charset="0"/>
      <p:regular r:id="rId23"/>
      <p:bold r:id="rId24"/>
      <p:italic r:id="rId25"/>
      <p:boldItalic r:id="rId26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26" Type="http://schemas.openxmlformats.org/officeDocument/2006/relationships/font" Target="fonts/font11.fntdata"/><Relationship Id="rId3" Type="http://schemas.openxmlformats.org/officeDocument/2006/relationships/slide" Target="slides/slide2.xml"/><Relationship Id="rId21" Type="http://schemas.openxmlformats.org/officeDocument/2006/relationships/font" Target="fonts/font6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25" Type="http://schemas.openxmlformats.org/officeDocument/2006/relationships/font" Target="fonts/font10.fntdata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20" Type="http://schemas.openxmlformats.org/officeDocument/2006/relationships/font" Target="fonts/font5.fntdata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9.fntdata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font" Target="fonts/font8.fntdata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7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6184241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1039768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33725327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076503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svg"/><Relationship Id="rId3" Type="http://schemas.openxmlformats.org/officeDocument/2006/relationships/image" Target="../media/image13.jpeg"/><Relationship Id="rId7" Type="http://schemas.openxmlformats.org/officeDocument/2006/relationships/image" Target="../media/image17.svg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svg"/><Relationship Id="rId5" Type="http://schemas.openxmlformats.org/officeDocument/2006/relationships/image" Target="../media/image15.sv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219149"/>
            <a:chOff x="1573698" y="-152998"/>
            <a:chExt cx="7219847" cy="1987255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846660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4</a:t>
              </a: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MOVE THOSE MUSCLES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ake the active cho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640826" y="1866276"/>
            <a:ext cx="7655574" cy="73558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Be AWARE of active opportunitie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Small choices add up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A little goes a long wa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CONTROL your sitting tim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Break up sedentary time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Get up and walk around 30-45 min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Cut down on screen &amp; TV ti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Choose to mov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Take the stair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Walk instead of driv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Walk around during commercial break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Park in a far away spot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3200" dirty="0"/>
          </a:p>
          <a:p>
            <a:endParaRPr lang="en-US" sz="2400" dirty="0"/>
          </a:p>
        </p:txBody>
      </p:sp>
      <p:pic>
        <p:nvPicPr>
          <p:cNvPr id="8198" name="Picture 6" descr="There is No Elevator to Success You Have to Take the Stairs | Etsy">
            <a:extLst>
              <a:ext uri="{FF2B5EF4-FFF2-40B4-BE49-F238E27FC236}">
                <a16:creationId xmlns:a16="http://schemas.microsoft.com/office/drawing/2014/main" id="{0E147E80-6F45-468B-8BA0-15CBD9E1BB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25199" y="1924480"/>
            <a:ext cx="6491561" cy="649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99329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ctivities I can choos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413655"/>
            <a:ext cx="14906144" cy="56015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Spontaneous activities I can do (select all)</a:t>
            </a:r>
          </a:p>
          <a:p>
            <a:endParaRPr lang="en-US" sz="18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Park in a far away spo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 the long way back on a walk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Jog in place during commercial break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a walking date with a frien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Run errands while walk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 an extra loop or two in the grocery st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alk a neighbor’s do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ll the abo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9218" name="Picture 2" descr="Why Enterprise SEO Needs a Champion">
            <a:extLst>
              <a:ext uri="{FF2B5EF4-FFF2-40B4-BE49-F238E27FC236}">
                <a16:creationId xmlns:a16="http://schemas.microsoft.com/office/drawing/2014/main" id="{77E00D8C-D5E9-43B6-8787-0468356D9B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/>
          <a:stretch/>
        </p:blipFill>
        <p:spPr bwMode="auto">
          <a:xfrm>
            <a:off x="11277600" y="7150608"/>
            <a:ext cx="5676900" cy="313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Keeping Track of What You Eat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sk yourself- can I do another 10 min of exercise today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im to do 30 min more this week than last week (a minimum of 60 min)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Give your recipes and  meals a healthy make-over!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Pages 12-14 of the handout gives tips to improve your meal plan!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Healthier snacks, ways to season food to make it taste delicious, cooking methods and more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810000" y="8188490"/>
            <a:ext cx="12768682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REMEMBER THIS WEEK’S TIP: </a:t>
            </a:r>
            <a:r>
              <a:rPr lang="en-US" sz="3200" b="1" u="sng" dirty="0">
                <a:solidFill>
                  <a:srgbClr val="FF0000"/>
                </a:solidFill>
              </a:rPr>
              <a:t>Check Your Breathing!</a:t>
            </a:r>
          </a:p>
          <a:p>
            <a:r>
              <a:rPr lang="en-US" sz="2800" dirty="0"/>
              <a:t>Getting your heart rate up a bit is the goal of moderate exercise, like a brisk paced walk. The best way to tell if you are getting a good pace is that your breathing is faster and its not as easy to talk while doing it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5755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Find new ways to get activit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meals, and track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 and step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ake your protein shake everyday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</a:t>
            </a:r>
            <a:r>
              <a:rPr lang="en-US" sz="3200">
                <a:latin typeface="Assistant" pitchFamily="2" charset="-79"/>
                <a:cs typeface="Assistant" pitchFamily="2" charset="-79"/>
              </a:rPr>
              <a:t>the response!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962900"/>
            <a:ext cx="11554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Build on successes, no one is perfec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Focus on what is working, look for creative solutions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y new veggies and protein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get 5,000 steps a day?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did you eat the most fa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2367826"/>
            <a:ext cx="10479651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was your most successful healthy swap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Vegetable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Fruit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rain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Protein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airy Food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l the abo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ne</a:t>
            </a: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057400" y="8642746"/>
            <a:ext cx="1546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SHARE YOUR STRATEGIES FOR SUCCESS IN THE CHAT!</a:t>
            </a:r>
          </a:p>
          <a:p>
            <a:r>
              <a:rPr lang="en-US" sz="2400" dirty="0"/>
              <a:t>Found a healthy swap that worked for you? WRITE IT IN THE CHAT NOW!</a:t>
            </a:r>
          </a:p>
          <a:p>
            <a:r>
              <a:rPr lang="en-US" sz="2400" dirty="0"/>
              <a:t>From food swaps to cooking choices, if it works for your it could really help others find motivation and delicious ideas!</a:t>
            </a:r>
          </a:p>
          <a:p>
            <a:endParaRPr lang="en-US" sz="2000" dirty="0"/>
          </a:p>
        </p:txBody>
      </p:sp>
      <p:pic>
        <p:nvPicPr>
          <p:cNvPr id="5" name="Graphic 4" descr="Cheers with solid fill">
            <a:extLst>
              <a:ext uri="{FF2B5EF4-FFF2-40B4-BE49-F238E27FC236}">
                <a16:creationId xmlns:a16="http://schemas.microsoft.com/office/drawing/2014/main" id="{E453062F-0802-4E53-B731-7167D3C0EE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31914" y="8642746"/>
            <a:ext cx="1449285" cy="1449285"/>
          </a:xfrm>
          <a:prstGeom prst="rect">
            <a:avLst/>
          </a:prstGeom>
        </p:spPr>
      </p:pic>
      <p:pic>
        <p:nvPicPr>
          <p:cNvPr id="22" name="Picture 2" descr="My plate ">
            <a:extLst>
              <a:ext uri="{FF2B5EF4-FFF2-40B4-BE49-F238E27FC236}">
                <a16:creationId xmlns:a16="http://schemas.microsoft.com/office/drawing/2014/main" id="{AE7A9A8B-6AF0-469C-9229-16FAF210FCB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72"/>
          <a:stretch/>
        </p:blipFill>
        <p:spPr bwMode="auto">
          <a:xfrm>
            <a:off x="11734800" y="3162300"/>
            <a:ext cx="5200650" cy="396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do you see your succes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59375" y="1475793"/>
            <a:ext cx="10479651" cy="8463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makes you feel like it is working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icking to my calorie/fat targets most meal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osing weigh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Having one really healthy meal a 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oing my 6,000 steps every 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Having more energ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ying new food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clothes fit bett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kipping junk foo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family or friends notice improvement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etting my steps in on most day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Those milestones are important to recognize and build on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How to set and achieve project milestones in Teamwork Projects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3946" y="3390900"/>
            <a:ext cx="6739467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t’s all about MOVING MORE!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629256" y="3012157"/>
            <a:ext cx="12086744" cy="7386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Planned activit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MODERATE activity, like a brisk walk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We start at 100 min a week, but aim for 150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Only count it if it lasts 10 min or more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Build up slow, don’t push yourself too har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Plan ahead- ask friends or fellow group members to go on regularly scheduled walks!</a:t>
            </a:r>
          </a:p>
          <a:p>
            <a:pPr marL="914400" lvl="1" indent="-457200">
              <a:buFontTx/>
              <a:buChar char="-"/>
            </a:pPr>
            <a:endParaRPr lang="en-US" sz="2000" dirty="0"/>
          </a:p>
          <a:p>
            <a:r>
              <a:rPr lang="en-US" sz="3200" b="1" u="sng" dirty="0"/>
              <a:t>Spontaneous Activit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Small increases like taking the stairs instead of the elevator, if you can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Housework and gardening is great for health and fun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Break up long sitting periods – walk around the house, yard, and get up to stretch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Try standing during our meetings, or when in other meetings too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Cut down on TV time, or watch TV while doing chores</a:t>
            </a:r>
          </a:p>
          <a:p>
            <a:pPr marL="914400" lvl="1" indent="-457200">
              <a:buFontTx/>
              <a:buChar char="-"/>
            </a:pPr>
            <a:endParaRPr lang="en-US" sz="3000" dirty="0"/>
          </a:p>
        </p:txBody>
      </p:sp>
      <p:pic>
        <p:nvPicPr>
          <p:cNvPr id="3076" name="Picture 4" descr="The missing mandate: Promoting physical activity to reduce disparities  during COVID-19 and beyond">
            <a:extLst>
              <a:ext uri="{FF2B5EF4-FFF2-40B4-BE49-F238E27FC236}">
                <a16:creationId xmlns:a16="http://schemas.microsoft.com/office/drawing/2014/main" id="{17478E15-4379-47D8-A7F4-744CDFAB4E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69665" y="1924481"/>
            <a:ext cx="6675385" cy="3219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y do we need to get moving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76400" y="2171700"/>
            <a:ext cx="15011400" cy="8032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More energ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Sleep Bett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Better able to chase after grandkid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Stay independent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Improve bone, joint, and muscle healt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Lower risk for diabetes, heart disease, and canc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Lower risk of dementia and Alzheimer’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Increase mental alertnes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Lower your blood press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Lower your blood gluco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Increase insulin sensitiv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3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b="1" i="1" u="sng" dirty="0"/>
              <a:t>Know anything else? PUT IT IN THE CHAT!</a:t>
            </a:r>
          </a:p>
          <a:p>
            <a:pPr lvl="2"/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4104" name="Picture 8" descr="Let's Get Moving! - Girlicity Girlicity">
            <a:extLst>
              <a:ext uri="{FF2B5EF4-FFF2-40B4-BE49-F238E27FC236}">
                <a16:creationId xmlns:a16="http://schemas.microsoft.com/office/drawing/2014/main" id="{A23A1A78-C7EE-4548-85C2-77E8CE3305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20400" y="5753100"/>
            <a:ext cx="7010126" cy="4206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Exercise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29256" y="2173456"/>
            <a:ext cx="9861753" cy="6432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b="1" dirty="0"/>
              <a:t>ACHIEVABLE GOAL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Started with 6,000 steps a day with 2,000+ “brisk”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Aiming for 150 min a week by Week 8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That’s as little as 22 min a day!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Spread moderate activity over 3+ day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10+ min of moderate activity at a time</a:t>
            </a:r>
            <a:endParaRPr lang="en-US" sz="32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GO SLOW! But build up over tim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Keep up activities you like and are used to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b="1" u="sng" dirty="0"/>
              <a:t>be safe and don’t push too hard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Aim to beat the exercise time from the previous week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Add 30 min each week</a:t>
            </a:r>
          </a:p>
          <a:p>
            <a:pPr marL="1657350" lvl="3" indent="-285750">
              <a:buFont typeface="Arial" panose="020B0604020202020204" pitchFamily="34" charset="0"/>
              <a:buChar char="•"/>
            </a:pPr>
            <a:r>
              <a:rPr lang="en-US" sz="3200" dirty="0"/>
              <a:t>That’s just 3 days with 10 min mo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22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6B4C1050-734E-41BB-B1E7-A24606B9F5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4097000" y="2958737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163266D-E4B7-43DB-9596-2862F03CD390}"/>
              </a:ext>
            </a:extLst>
          </p:cNvPr>
          <p:cNvSpPr txBox="1"/>
          <p:nvPr/>
        </p:nvSpPr>
        <p:spPr>
          <a:xfrm>
            <a:off x="13338106" y="5388620"/>
            <a:ext cx="4264094" cy="4462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</a:p>
          <a:p>
            <a:r>
              <a:rPr lang="en-US" sz="3200" b="1" i="1" u="sng" dirty="0">
                <a:solidFill>
                  <a:srgbClr val="FF0000"/>
                </a:solidFill>
              </a:rPr>
              <a:t>Check Your Breathing!</a:t>
            </a:r>
          </a:p>
          <a:p>
            <a:r>
              <a:rPr lang="en-US" sz="2800" dirty="0"/>
              <a:t>Getting your heart rate up a bit is the goal of moderate exercise, like a brisk paced walk.  The best way to tell if you are getting a good pace is that your breathing is faster and its not as easy to talk while doing it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8295452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Exercise Pla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638300" y="2004192"/>
            <a:ext cx="15963900" cy="6432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Strategies for Succes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Set aside tim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Prioritize your health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Plan ahead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Otherwise life will interfer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Make it social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Walk with friends, family, and group member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Hold each other accountabl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Record moderate activity over 10+ min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You deserve credit!!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Make a Schedul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Plan ahead and get into a routin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6148" name="Picture 4" descr="2020 Fitness Planner Free Printable - Simply Stacie">
            <a:extLst>
              <a:ext uri="{FF2B5EF4-FFF2-40B4-BE49-F238E27FC236}">
                <a16:creationId xmlns:a16="http://schemas.microsoft.com/office/drawing/2014/main" id="{58189D22-F3D6-4EAF-B78B-B44E61D74B9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98"/>
          <a:stretch/>
        </p:blipFill>
        <p:spPr bwMode="auto">
          <a:xfrm>
            <a:off x="10926085" y="1988952"/>
            <a:ext cx="6394992" cy="7961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Graphic 16" descr="Shoe footprints outline">
            <a:extLst>
              <a:ext uri="{FF2B5EF4-FFF2-40B4-BE49-F238E27FC236}">
                <a16:creationId xmlns:a16="http://schemas.microsoft.com/office/drawing/2014/main" id="{F1F0932E-E585-4964-9489-0F1F1BF102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4782800" y="4519159"/>
            <a:ext cx="685800" cy="685800"/>
          </a:xfrm>
          <a:prstGeom prst="rect">
            <a:avLst/>
          </a:prstGeom>
        </p:spPr>
      </p:pic>
      <p:pic>
        <p:nvPicPr>
          <p:cNvPr id="30" name="Graphic 29" descr="Shoe footprints outline">
            <a:extLst>
              <a:ext uri="{FF2B5EF4-FFF2-40B4-BE49-F238E27FC236}">
                <a16:creationId xmlns:a16="http://schemas.microsoft.com/office/drawing/2014/main" id="{4B6DC460-1CE4-4ACA-9A5C-C02E9036C2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4782800" y="6057900"/>
            <a:ext cx="685800" cy="685800"/>
          </a:xfrm>
          <a:prstGeom prst="rect">
            <a:avLst/>
          </a:prstGeom>
        </p:spPr>
      </p:pic>
      <p:pic>
        <p:nvPicPr>
          <p:cNvPr id="31" name="Graphic 30" descr="Shoe footprints outline">
            <a:extLst>
              <a:ext uri="{FF2B5EF4-FFF2-40B4-BE49-F238E27FC236}">
                <a16:creationId xmlns:a16="http://schemas.microsoft.com/office/drawing/2014/main" id="{3DF47A67-4D25-42F7-BECA-23AEC24547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4782800" y="7661284"/>
            <a:ext cx="685800" cy="685800"/>
          </a:xfrm>
          <a:prstGeom prst="rect">
            <a:avLst/>
          </a:prstGeom>
        </p:spPr>
      </p:pic>
      <p:pic>
        <p:nvPicPr>
          <p:cNvPr id="24" name="Graphic 23" descr="Yoga outline">
            <a:extLst>
              <a:ext uri="{FF2B5EF4-FFF2-40B4-BE49-F238E27FC236}">
                <a16:creationId xmlns:a16="http://schemas.microsoft.com/office/drawing/2014/main" id="{0E269DA4-3052-4120-AD1E-CBAA74AAA0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2036261" y="4504758"/>
            <a:ext cx="685800" cy="685800"/>
          </a:xfrm>
          <a:prstGeom prst="rect">
            <a:avLst/>
          </a:prstGeom>
        </p:spPr>
      </p:pic>
      <p:pic>
        <p:nvPicPr>
          <p:cNvPr id="34" name="Graphic 33" descr="Yoga outline">
            <a:extLst>
              <a:ext uri="{FF2B5EF4-FFF2-40B4-BE49-F238E27FC236}">
                <a16:creationId xmlns:a16="http://schemas.microsoft.com/office/drawing/2014/main" id="{23A1F97F-FA01-4BE4-84B0-E2526B30C42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997231" y="6057900"/>
            <a:ext cx="685800" cy="685800"/>
          </a:xfrm>
          <a:prstGeom prst="rect">
            <a:avLst/>
          </a:prstGeom>
        </p:spPr>
      </p:pic>
      <p:pic>
        <p:nvPicPr>
          <p:cNvPr id="35" name="Graphic 34" descr="Yoga outline">
            <a:extLst>
              <a:ext uri="{FF2B5EF4-FFF2-40B4-BE49-F238E27FC236}">
                <a16:creationId xmlns:a16="http://schemas.microsoft.com/office/drawing/2014/main" id="{BAF3DDF7-7470-4EAD-9865-87F5047D780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993035" y="7597008"/>
            <a:ext cx="685800" cy="685800"/>
          </a:xfrm>
          <a:prstGeom prst="rect">
            <a:avLst/>
          </a:prstGeom>
        </p:spPr>
      </p:pic>
      <p:pic>
        <p:nvPicPr>
          <p:cNvPr id="32" name="Graphic 31" descr="Walk outline">
            <a:extLst>
              <a:ext uri="{FF2B5EF4-FFF2-40B4-BE49-F238E27FC236}">
                <a16:creationId xmlns:a16="http://schemas.microsoft.com/office/drawing/2014/main" id="{243190C7-3703-4DD6-877A-687869A9232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3352189" y="4504758"/>
            <a:ext cx="685800" cy="685800"/>
          </a:xfrm>
          <a:prstGeom prst="rect">
            <a:avLst/>
          </a:prstGeom>
        </p:spPr>
      </p:pic>
      <p:pic>
        <p:nvPicPr>
          <p:cNvPr id="38" name="Graphic 37" descr="Walk outline">
            <a:extLst>
              <a:ext uri="{FF2B5EF4-FFF2-40B4-BE49-F238E27FC236}">
                <a16:creationId xmlns:a16="http://schemas.microsoft.com/office/drawing/2014/main" id="{4132A62B-B188-4579-A2B1-542CC83FB89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3337797" y="6007946"/>
            <a:ext cx="685800" cy="685800"/>
          </a:xfrm>
          <a:prstGeom prst="rect">
            <a:avLst/>
          </a:prstGeom>
        </p:spPr>
      </p:pic>
      <p:pic>
        <p:nvPicPr>
          <p:cNvPr id="39" name="Graphic 38" descr="Walk outline">
            <a:extLst>
              <a:ext uri="{FF2B5EF4-FFF2-40B4-BE49-F238E27FC236}">
                <a16:creationId xmlns:a16="http://schemas.microsoft.com/office/drawing/2014/main" id="{FDF66F0E-5EC4-4861-B7DB-CBAA099BC4D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3352189" y="7576433"/>
            <a:ext cx="685800" cy="685800"/>
          </a:xfrm>
          <a:prstGeom prst="rect">
            <a:avLst/>
          </a:prstGeom>
        </p:spPr>
      </p:pic>
      <p:pic>
        <p:nvPicPr>
          <p:cNvPr id="36" name="Graphic 35" descr="Stopwatch 33% with solid fill">
            <a:extLst>
              <a:ext uri="{FF2B5EF4-FFF2-40B4-BE49-F238E27FC236}">
                <a16:creationId xmlns:a16="http://schemas.microsoft.com/office/drawing/2014/main" id="{E7DE7A5F-4FBD-4CDE-A6D1-AE8E4410302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992556" y="4489632"/>
            <a:ext cx="672384" cy="672384"/>
          </a:xfrm>
          <a:prstGeom prst="rect">
            <a:avLst/>
          </a:prstGeom>
        </p:spPr>
      </p:pic>
      <p:pic>
        <p:nvPicPr>
          <p:cNvPr id="42" name="Graphic 41" descr="Stopwatch 33% with solid fill">
            <a:extLst>
              <a:ext uri="{FF2B5EF4-FFF2-40B4-BE49-F238E27FC236}">
                <a16:creationId xmlns:a16="http://schemas.microsoft.com/office/drawing/2014/main" id="{FFACA7E3-181C-4533-B49B-64D6835A750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984997" y="6075863"/>
            <a:ext cx="672384" cy="672384"/>
          </a:xfrm>
          <a:prstGeom prst="rect">
            <a:avLst/>
          </a:prstGeom>
        </p:spPr>
      </p:pic>
      <p:pic>
        <p:nvPicPr>
          <p:cNvPr id="43" name="Graphic 42" descr="Stopwatch 33% with solid fill">
            <a:extLst>
              <a:ext uri="{FF2B5EF4-FFF2-40B4-BE49-F238E27FC236}">
                <a16:creationId xmlns:a16="http://schemas.microsoft.com/office/drawing/2014/main" id="{E902BF02-C059-4E66-BBA2-77E8909F650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993957" y="7610424"/>
            <a:ext cx="672384" cy="67238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32964752-A24C-4353-8F09-035C8D0C5C76}"/>
              </a:ext>
            </a:extLst>
          </p:cNvPr>
          <p:cNvSpPr txBox="1"/>
          <p:nvPr/>
        </p:nvSpPr>
        <p:spPr>
          <a:xfrm>
            <a:off x="15468600" y="3524700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ept 202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067FFD2-9AAA-4A5A-8B48-E0DFD114243B}"/>
              </a:ext>
            </a:extLst>
          </p:cNvPr>
          <p:cNvSpPr txBox="1"/>
          <p:nvPr/>
        </p:nvSpPr>
        <p:spPr>
          <a:xfrm>
            <a:off x="11811000" y="3513531"/>
            <a:ext cx="9148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Total Min: 100</a:t>
            </a:r>
          </a:p>
        </p:txBody>
      </p:sp>
      <p:pic>
        <p:nvPicPr>
          <p:cNvPr id="47" name="Graphic 46" descr="Shoe footprints outline">
            <a:extLst>
              <a:ext uri="{FF2B5EF4-FFF2-40B4-BE49-F238E27FC236}">
                <a16:creationId xmlns:a16="http://schemas.microsoft.com/office/drawing/2014/main" id="{3C9CBBBA-1C6A-4492-B9ED-9A4D8A7F1D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4782800" y="9188686"/>
            <a:ext cx="685800" cy="685800"/>
          </a:xfrm>
          <a:prstGeom prst="rect">
            <a:avLst/>
          </a:prstGeom>
        </p:spPr>
      </p:pic>
      <p:pic>
        <p:nvPicPr>
          <p:cNvPr id="48" name="Graphic 47" descr="Yoga outline">
            <a:extLst>
              <a:ext uri="{FF2B5EF4-FFF2-40B4-BE49-F238E27FC236}">
                <a16:creationId xmlns:a16="http://schemas.microsoft.com/office/drawing/2014/main" id="{575306A1-3F77-4773-B071-B49A12D1898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993035" y="9124410"/>
            <a:ext cx="685800" cy="685800"/>
          </a:xfrm>
          <a:prstGeom prst="rect">
            <a:avLst/>
          </a:prstGeom>
        </p:spPr>
      </p:pic>
      <p:pic>
        <p:nvPicPr>
          <p:cNvPr id="49" name="Graphic 48" descr="Walk outline">
            <a:extLst>
              <a:ext uri="{FF2B5EF4-FFF2-40B4-BE49-F238E27FC236}">
                <a16:creationId xmlns:a16="http://schemas.microsoft.com/office/drawing/2014/main" id="{DD8B5776-120E-48B5-915D-EFA5CE5A8C0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3352189" y="9103835"/>
            <a:ext cx="685800" cy="685800"/>
          </a:xfrm>
          <a:prstGeom prst="rect">
            <a:avLst/>
          </a:prstGeom>
        </p:spPr>
      </p:pic>
      <p:pic>
        <p:nvPicPr>
          <p:cNvPr id="50" name="Graphic 49" descr="Stopwatch 33% with solid fill">
            <a:extLst>
              <a:ext uri="{FF2B5EF4-FFF2-40B4-BE49-F238E27FC236}">
                <a16:creationId xmlns:a16="http://schemas.microsoft.com/office/drawing/2014/main" id="{B0832529-B52B-4887-BC36-88F93AAB772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993957" y="9137826"/>
            <a:ext cx="672384" cy="672384"/>
          </a:xfrm>
          <a:prstGeom prst="rect">
            <a:avLst/>
          </a:prstGeom>
        </p:spPr>
      </p:pic>
      <p:pic>
        <p:nvPicPr>
          <p:cNvPr id="44" name="Graphic 43" descr="Award ribbon with star">
            <a:extLst>
              <a:ext uri="{FF2B5EF4-FFF2-40B4-BE49-F238E27FC236}">
                <a16:creationId xmlns:a16="http://schemas.microsoft.com/office/drawing/2014/main" id="{3BD9BA97-64F4-455D-89FA-41E59F41000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 rot="1370493">
            <a:off x="9330573" y="818347"/>
            <a:ext cx="3915969" cy="3915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73504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Exercise Safet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519513" y="1740284"/>
            <a:ext cx="15963900" cy="7663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b="1" u="sng" dirty="0"/>
              <a:t>EXERCISE RECIP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Warm Up for 5-10 min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A leisurely paced walk works well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Stretch for 5-10 min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Stretch after you get your blood flowing! Check pages 13-16 for stretch ideas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Stay in Your Comfort Zon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Stick with what you know and what your body can handl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Aim for Balanc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Build up slowly, work both sides of your body equally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Remember to Breath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Steady rhythmic breathing makes exercise better and can tell you how strenuous it i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Cool down for 5-10 min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A relaxed version of the exercise you were doing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600" dirty="0"/>
              <a:t>Stretch (again)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400" dirty="0"/>
              <a:t>Stretching after a workout can help reduce sore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E2AD42C-3810-46A0-87B4-9904E0994AB5}"/>
              </a:ext>
            </a:extLst>
          </p:cNvPr>
          <p:cNvSpPr txBox="1"/>
          <p:nvPr/>
        </p:nvSpPr>
        <p:spPr>
          <a:xfrm>
            <a:off x="2111416" y="8937174"/>
            <a:ext cx="1546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PAIN IS NOT GAIN! Start small and build up strength. Soreness is ok but PAINFUL is a sign to stop. If pain persists, please seek medical attention and let us know too! </a:t>
            </a:r>
            <a:r>
              <a:rPr lang="en-US" sz="2400" b="1" u="sng" dirty="0"/>
              <a:t>Review page 10 to know when to stop and what to look for to stay safe!</a:t>
            </a:r>
          </a:p>
          <a:p>
            <a:endParaRPr lang="en-US" sz="2000" dirty="0"/>
          </a:p>
        </p:txBody>
      </p:sp>
      <p:pic>
        <p:nvPicPr>
          <p:cNvPr id="27" name="Graphic 26" descr="Bullseye outline">
            <a:extLst>
              <a:ext uri="{FF2B5EF4-FFF2-40B4-BE49-F238E27FC236}">
                <a16:creationId xmlns:a16="http://schemas.microsoft.com/office/drawing/2014/main" id="{1B868CBE-A9CF-44FD-BD2E-F920099115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7172" name="Picture 4" descr="Amazon.com: Stretching Exercises for Seniors: Simple Movements to Improve  Posture, Decrease Back Pain, and Prevent Injury After 60 (Strength Training  for Seniors) eBook : Thompson, Baz, Lynch, Britney: Kindle Store">
            <a:extLst>
              <a:ext uri="{FF2B5EF4-FFF2-40B4-BE49-F238E27FC236}">
                <a16:creationId xmlns:a16="http://schemas.microsoft.com/office/drawing/2014/main" id="{C23E57DB-DCB6-4585-ACF5-6B72BA73E8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6704" y="2651667"/>
            <a:ext cx="4016416" cy="5704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84542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82</TotalTime>
  <Words>1239</Words>
  <Application>Microsoft Office PowerPoint</Application>
  <PresentationFormat>Custom</PresentationFormat>
  <Paragraphs>223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2" baseType="lpstr">
      <vt:lpstr>Assistant ExtraBold</vt:lpstr>
      <vt:lpstr>Courier New</vt:lpstr>
      <vt:lpstr>Assistant SemiBold</vt:lpstr>
      <vt:lpstr>Assistant Bold</vt:lpstr>
      <vt:lpstr>Assistant Regular</vt:lpstr>
      <vt:lpstr>Calibri</vt:lpstr>
      <vt:lpstr>Arial</vt:lpstr>
      <vt:lpstr>Assistan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206</cp:revision>
  <dcterms:created xsi:type="dcterms:W3CDTF">2006-08-16T00:00:00Z</dcterms:created>
  <dcterms:modified xsi:type="dcterms:W3CDTF">2023-11-03T20:43:04Z</dcterms:modified>
  <dc:identifier>DAE7nbwep5o</dc:identifier>
</cp:coreProperties>
</file>